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14075431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6327"/>
  </p:normalViewPr>
  <p:slideViewPr>
    <p:cSldViewPr snapToGrid="0" snapToObjects="1" showGuides="1">
      <p:cViewPr varScale="1">
        <p:scale>
          <a:sx n="128" d="100"/>
          <a:sy n="128" d="100"/>
        </p:scale>
        <p:origin x="480" y="17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498B368-F1B3-0245-95A4-8A5768AB854F}" type="datetimeFigureOut">
              <a:rPr lang="en-US" smtClean="0"/>
              <a:t>6/27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654732-3731-D34B-A754-A38BD1D213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3127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6D4B4D-86AA-2D8B-49C9-B9730EB40A9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632E16B-998E-C07C-46DF-A2A359F9AAC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FAAD85-AB7F-2BD5-CC76-8617642D98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4144AE-C7EF-A1B1-3DF8-AC3A3EC46C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874B88-59EE-7ACE-EE58-CFDE8A40AF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54129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646BCD-3DA5-7EA2-1E41-C25DCA4AA4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20D5E7B-83C0-A78B-1F0E-DDE0115054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BF3E42-D991-C08A-8527-15E816CAF3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2D6FCB-A00A-E1AD-70BB-07A34490D2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5AEB75-EB08-C39D-B1CF-63C8704061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80733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CD7C3C5-71C0-A1B2-9F1F-887D392FD73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78EE4FF-0CB6-7D57-F380-770CED4ED50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BCBFCF-8EBD-F4B4-2D80-0B4ECE8FA2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494CF6-5D71-408F-63AF-14742B78C0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02F832-B7F9-D4D6-70EB-D52EED4B81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236273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7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06B85D-899C-944F-A2E0-4894DCE9224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Subtitle 2">
            <a:extLst>
              <a:ext uri="{FF2B5EF4-FFF2-40B4-BE49-F238E27FC236}">
                <a16:creationId xmlns:a16="http://schemas.microsoft.com/office/drawing/2014/main" id="{E28CA5FF-AACC-4AB7-B6E7-D6A63EA944DB}"/>
              </a:ext>
            </a:extLst>
          </p:cNvPr>
          <p:cNvSpPr>
            <a:spLocks noGrp="1"/>
          </p:cNvSpPr>
          <p:nvPr>
            <p:ph type="subTitle" idx="10" hasCustomPrompt="1"/>
          </p:nvPr>
        </p:nvSpPr>
        <p:spPr>
          <a:xfrm>
            <a:off x="614853" y="1161597"/>
            <a:ext cx="10962290" cy="276999"/>
          </a:xfrm>
        </p:spPr>
        <p:txBody>
          <a:bodyPr wrap="square">
            <a:spAutoFit/>
          </a:bodyPr>
          <a:lstStyle>
            <a:lvl1pPr marL="0" indent="0" algn="l">
              <a:buNone/>
              <a:defRPr sz="2000" b="0" i="0" baseline="0">
                <a:solidFill>
                  <a:schemeClr val="accent3"/>
                </a:solidFill>
                <a:latin typeface="+mn-lt"/>
                <a:cs typeface="Gotham Bold" pitchFamily="2" charset="0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subtitle</a:t>
            </a: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EDEDEA15-1C46-42C0-9541-5C897D1A89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6" name="Footnotes">
            <a:extLst>
              <a:ext uri="{FF2B5EF4-FFF2-40B4-BE49-F238E27FC236}">
                <a16:creationId xmlns:a16="http://schemas.microsoft.com/office/drawing/2014/main" id="{38ABFE29-F12E-4908-BBBE-F167F72BD474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614854" y="6019800"/>
            <a:ext cx="9139237" cy="352572"/>
          </a:xfrm>
        </p:spPr>
        <p:txBody>
          <a:bodyPr anchor="b">
            <a:noAutofit/>
          </a:bodyPr>
          <a:lstStyle>
            <a:lvl1pPr marL="115888" indent="-115888">
              <a:spcBef>
                <a:spcPts val="300"/>
              </a:spcBef>
              <a:spcAft>
                <a:spcPts val="0"/>
              </a:spcAft>
              <a:buFont typeface="+mj-lt"/>
              <a:buAutoNum type="arabicPeriod"/>
              <a:defRPr sz="800">
                <a:solidFill>
                  <a:schemeClr val="tx2"/>
                </a:solidFill>
                <a:latin typeface="+mn-lt"/>
              </a:defRPr>
            </a:lvl1pPr>
            <a:lvl2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2pPr>
            <a:lvl3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3pPr>
            <a:lvl4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4pPr>
            <a:lvl5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5pPr>
            <a:lvl6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6pPr>
            <a:lvl7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7pPr>
            <a:lvl8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8pPr>
            <a:lvl9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9pPr>
          </a:lstStyle>
          <a:p>
            <a:pPr lvl="0"/>
            <a:r>
              <a:rPr lang="en-US"/>
              <a:t>Click to add a reference</a:t>
            </a:r>
          </a:p>
        </p:txBody>
      </p:sp>
    </p:spTree>
    <p:extLst>
      <p:ext uri="{BB962C8B-B14F-4D97-AF65-F5344CB8AC3E}">
        <p14:creationId xmlns:p14="http://schemas.microsoft.com/office/powerpoint/2010/main" val="934693454"/>
      </p:ext>
    </p:extLst>
  </p:cSld>
  <p:clrMapOvr>
    <a:masterClrMapping/>
  </p:clrMapOvr>
  <p:transition spd="med">
    <p:fade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1E4477-E2C6-333E-7719-D0110A0908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211F44-6541-C656-9423-672E6D4C77D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29360A-D345-B9A3-98F9-2562CCC59F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E9D474-E09B-F229-AB05-E741B9383A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D80891-93F2-2BDA-12FD-391EF77104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7529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D10A86-25F3-EC62-2093-A0ACF40761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8D1118-8BAB-76B5-FEC7-9E984780E6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6786A5-6961-99B3-B7EB-B08C9FB7AD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D05593-D3B5-A46B-1E20-3B42FE3BD3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DAF183-D6B4-F12F-D3B6-BE37280548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2173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D50339-6B24-28B7-6731-6F50E65F6F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FF5F1F-0CC3-D379-35E9-AD524FCE355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75D30D2-22CF-A94E-163A-05B2B4A6BD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30F88EA-B300-6990-1E88-45239B2589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BAA1BEC-C618-848F-79D7-BA954C8898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31C6AC-69F2-5A13-03C3-3AD481CA91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680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627115-C71D-868B-9F4C-036DB1422F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CB570CC-37EC-5849-B1AE-CF42709C63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723A815-562C-CA29-DF83-E3B05239E1D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3DA066F-F142-A310-FBC5-11C5467C2E3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98045C0-914C-67C6-2AB6-E07E6944A4C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83214B8-9017-1262-AFAC-B7D33BC338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F9F62EE-DAB4-B597-8FFF-B358848CD0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D738EFA-0729-2895-CC19-0D8A1CE2B7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29370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D62CF3-AE73-DB7D-1832-42A1839918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F82E599-7E90-14DC-69BE-FE02C24707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B84F30C-C766-9DF0-2F92-574037DD09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2463212-7AB9-4CCE-05AE-4AC30D8979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58725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50F5844-E514-2665-0563-A742A46D50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1C0F884-2473-FEBA-C949-15C20EB5D1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66191E0-7615-C448-3E88-96FC4E4BF0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06507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EBBDE2-AC71-BB30-926A-AC6C84A77F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A5F1FCB-4A60-EECB-216B-78FED4CE6C3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A9111C4-7F35-030A-B351-BEFC9876DA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CBAEC91-AA23-18EF-976F-CE19C3A6DA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BE547F-263A-36B2-F6EC-F1692140AA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533B1D8-A907-D8BE-F3BD-5A81D708A5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60518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2FE9E7-0B82-593B-427F-E268B23E06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7019921-432F-E8A3-FE40-2108DAC74A6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0D1C407-FD24-64F3-FB38-C90E252D59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4FE28B-DC92-0E6F-6691-8FB68A8A86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0E5EB2-A374-0635-223E-B497A52800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65BC3EB-9B62-4587-EC39-B7B1EB86BD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10090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F579E1B-4AD0-A052-060E-38E99E5F92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AE9465-F527-A2C4-C944-745A6C335A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C55A13-8B0A-9713-675C-36D57B45C1B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D0A70C-5E4E-D09F-3996-A0A001D4F96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C7EC20-85C0-BCBD-ABF8-AA0F691DADF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88396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92B37F44-6ACC-6B40-BF04-DA8B1325E1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96805" y="605457"/>
            <a:ext cx="5051546" cy="512256"/>
          </a:xfrm>
        </p:spPr>
        <p:txBody>
          <a:bodyPr>
            <a:noAutofit/>
          </a:bodyPr>
          <a:lstStyle/>
          <a:p>
            <a:r>
              <a:rPr lang="en-US" sz="1600" dirty="0">
                <a:latin typeface="Calibri" panose="020F0502020204030204" pitchFamily="34" charset="0"/>
                <a:cs typeface="Calibri" panose="020F0502020204030204" pitchFamily="34" charset="0"/>
              </a:rPr>
              <a:t>Supplemental Table S2: Patient demographics in Sequential Cohort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295163AB-614E-904E-97DD-88AB8C026050}"/>
              </a:ext>
            </a:extLst>
          </p:cNvPr>
          <p:cNvGraphicFramePr>
            <a:graphicFrameLocks noGrp="1"/>
          </p:cNvGraphicFramePr>
          <p:nvPr/>
        </p:nvGraphicFramePr>
        <p:xfrm>
          <a:off x="7383968" y="73268"/>
          <a:ext cx="4020644" cy="6711464"/>
        </p:xfrm>
        <a:graphic>
          <a:graphicData uri="http://schemas.openxmlformats.org/drawingml/2006/table">
            <a:tbl>
              <a:tblPr firstRow="1" bandRow="1">
                <a:tableStyleId>{8EC20E35-A176-4012-BC5E-935CFFF8708E}</a:tableStyleId>
              </a:tblPr>
              <a:tblGrid>
                <a:gridCol w="1402965">
                  <a:extLst>
                    <a:ext uri="{9D8B030D-6E8A-4147-A177-3AD203B41FA5}">
                      <a16:colId xmlns:a16="http://schemas.microsoft.com/office/drawing/2014/main" val="1586986838"/>
                    </a:ext>
                  </a:extLst>
                </a:gridCol>
                <a:gridCol w="721299">
                  <a:extLst>
                    <a:ext uri="{9D8B030D-6E8A-4147-A177-3AD203B41FA5}">
                      <a16:colId xmlns:a16="http://schemas.microsoft.com/office/drawing/2014/main" val="3940524065"/>
                    </a:ext>
                  </a:extLst>
                </a:gridCol>
                <a:gridCol w="689593">
                  <a:extLst>
                    <a:ext uri="{9D8B030D-6E8A-4147-A177-3AD203B41FA5}">
                      <a16:colId xmlns:a16="http://schemas.microsoft.com/office/drawing/2014/main" val="3471467173"/>
                    </a:ext>
                  </a:extLst>
                </a:gridCol>
                <a:gridCol w="689593">
                  <a:extLst>
                    <a:ext uri="{9D8B030D-6E8A-4147-A177-3AD203B41FA5}">
                      <a16:colId xmlns:a16="http://schemas.microsoft.com/office/drawing/2014/main" val="626314112"/>
                    </a:ext>
                  </a:extLst>
                </a:gridCol>
                <a:gridCol w="517194">
                  <a:extLst>
                    <a:ext uri="{9D8B030D-6E8A-4147-A177-3AD203B41FA5}">
                      <a16:colId xmlns:a16="http://schemas.microsoft.com/office/drawing/2014/main" val="3994496854"/>
                    </a:ext>
                  </a:extLst>
                </a:gridCol>
              </a:tblGrid>
              <a:tr h="71333"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TMB &lt; 10 (N=47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TMB10 (N=17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Total (N=64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p value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158727181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Age at Dx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0.407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174636983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  Median (Q1, Q3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68.0 (56.5, 73.0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69.0 (63.0, 75.0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68.0 (57.8, 74.2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3768614499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Sex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0.624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1344281770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  F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11 (23.4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5 (29.4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16 (25.0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4074451322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  M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36 (76.6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12 (70.6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48 (75.0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3634281855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Race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0.095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4003434988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  African American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1 (2.1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2 (11.8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3 (4.7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520661025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  European American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27 (57.4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12 (70.6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39 (60.9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317848118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  Other or Unknown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19 (40.4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3 (17.6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22 (34.4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1368177302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Practice Type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0.729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2045902169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  Academic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4 (8.5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1 (5.9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5 (7.8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3812651966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  Community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43 (91.5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16 (94.1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59 (92.2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1503241799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Site of Primary Tumor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0.864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1967701850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  Esophageal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16 (34.0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6 (35.3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22 (34.4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1557159759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  Gastric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14 (29.8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6 (35.3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20 (31.2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2193743753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  Gastroesophageal Junction (GEJ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17 (36.2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5 (29.4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22 (34.4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2691883981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Stage at Dx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0.209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2135662194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  Stage I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0 (0.0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1 (5.9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1 (1.6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3104712979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  Stage II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4 (8.5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0 (0.0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4 (6.2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1212353069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  Stage III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7 (14.9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2 (11.8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9 (14.1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4026577469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  Stage IV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31 (66.0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10 (58.8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41 (64.1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3989337323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  Unknown/not documented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5 (10.6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4 (23.5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9 (14.1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835273456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History of Smoking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0.89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1445400272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  History of smoking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34 (72.3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12 (70.6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46 (71.9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4034544097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  No history of smoking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13 (27.7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5 (29.4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18 (28.1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3879375629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Prior Surgery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0.75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1713808950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  No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37 (78.7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14 (82.4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51 (79.7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1569709040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  Yes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10 (21.3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3 (17.6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13 (20.3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2101776323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ECOG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0.718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2939488466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1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19 (45.2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8 (57.1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27 (48.2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1668697212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2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18 (42.9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5 (35.7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23 (41.1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1146657583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  3+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5 (11.9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1 (7.1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6 (10.7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2894598233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  Missing Observations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5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3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8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3768261612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HER2 IHC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0.508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4240216199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  Negative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39 (83.0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16 (94.1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55 (85.9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478671194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  Positive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1 (2.1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0 (0.0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1 (1.6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1436095160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  unknown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7 (14.9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1 (5.9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8 (12.5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3210722167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TMB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&lt; 0.001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2137811249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  Median (Q1, Q3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3.8 (1.3, 5.2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31.3 (13.8, 36.5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4.7 (2.5, 10.6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2085904714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MSI by NGS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&lt; 0.001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2509434614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  MSI unknown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11 (23.4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1 (5.9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12 (18.8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2338673067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  MSI-H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0 (0.0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14 (82.4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14 (21.9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3647865676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  MSS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36 (76.6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2 (11.8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38 (59.4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2214127146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PDL1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0.367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1193322970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  CPS 0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3 (6.4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0 (0.0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3 (4.7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2646919167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  CPS 1-4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9 (19.1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1 (5.9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10 (15.6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3927991881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  CPS 10+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14 (29.8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4 (23.5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18 (28.1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755571716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  CPS 5-9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5 (10.6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3 (17.6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8 (12.5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772843295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  unknown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16 (34.0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9 (52.9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25 (39.1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3661941527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Albumin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0.885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1342747443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  Below LLN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6 (14.0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2 (12.5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8 (13.6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1133937430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  Normal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37 (86.0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14 (87.5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51 (86.4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2829968527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  Missing Observations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4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1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5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810482012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Bilirubin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&lt; 0.001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1461922930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  Normal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43 (100.0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16 (100.0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59 (100.0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4266721915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  Missing Observations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4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1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5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539951757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Cr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0.284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4260785171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  Above ULN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3 (6.8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0 (0.0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3 (5.0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2913653866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  Normal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41 (93.2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16 (100.0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57 (95.0%)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2649508504"/>
                  </a:ext>
                </a:extLst>
              </a:tr>
              <a:tr h="7133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  Missing Observations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3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1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4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44" marR="3344" marT="3344" marB="0" anchor="b"/>
                </a:tc>
                <a:extLst>
                  <a:ext uri="{0D108BD9-81ED-4DB2-BD59-A6C34878D82A}">
                    <a16:rowId xmlns:a16="http://schemas.microsoft.com/office/drawing/2014/main" val="21257707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75719763"/>
      </p:ext>
    </p:extLst>
  </p:cSld>
  <p:clrMapOvr>
    <a:masterClrMapping/>
  </p:clrMapOvr>
  <p:transition spd="med">
    <p:fade/>
  </p:transition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713</Words>
  <Application>Microsoft Macintosh PowerPoint</Application>
  <PresentationFormat>Widescreen</PresentationFormat>
  <Paragraphs>2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Supplemental Table S2: Patient demographics in Sequential Cohor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Tables &amp; Figures</dc:title>
  <dc:creator>Klempner, Samuel J.,MD</dc:creator>
  <cp:lastModifiedBy>Klempner, Samuel J.,MD</cp:lastModifiedBy>
  <cp:revision>4</cp:revision>
  <dcterms:created xsi:type="dcterms:W3CDTF">2022-06-12T16:24:02Z</dcterms:created>
  <dcterms:modified xsi:type="dcterms:W3CDTF">2022-06-27T19:52:51Z</dcterms:modified>
</cp:coreProperties>
</file>